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2588" cy="98567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199E2-984E-4457-8C63-8C47AD3DA7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553C0-6E2B-4923-99CD-4C5FEE35CC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8145B-4147-4E59-9C57-825B9F5604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173A8-0062-4582-AA9A-92A330AD2B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662F3-05A5-48AA-AF27-7440B8092F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02536-5C98-4F70-91AC-7763D40831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62C21-B81A-40C4-AB9D-44DE7E10D9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34C73-6607-4F9E-A37D-3F7D3F3972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A94B8-D2B5-4EF8-A0A0-3D1E3640A1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2184F-B86C-438A-BA25-1B6C9BCDD8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17F0F-52CB-4B9A-979A-EFE9F28FEE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533C0-16F0-4A0B-8380-D7032ED909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CF81BE-6DBB-4B56-B545-B853092FA6A0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genome-www.stanford.edu/Human-CellCycle/Hela/explore.shtml" TargetMode="External"/><Relationship Id="rId2" Type="http://schemas.openxmlformats.org/officeDocument/2006/relationships/hyperlink" Target="http://genome-www.stanford.edu/Human-CellCycle/Hela/explore.shtml" TargetMode="External"/><Relationship Id="rId3" Type="http://schemas.openxmlformats.org/officeDocument/2006/relationships/hyperlink" Target="http://genome-www.stanford.edu/Human-CellCycle/Hela/explore.shtml" TargetMode="External"/><Relationship Id="rId4" Type="http://schemas.openxmlformats.org/officeDocument/2006/relationships/hyperlink" Target="http://genome-www.stanford.edu/Human-CellCycle/Hela/explore.shtml" TargetMode="External"/><Relationship Id="rId5" Type="http://schemas.openxmlformats.org/officeDocument/2006/relationships/hyperlink" Target="http://genome-www.stanford.edu/Human-CellCycle/Hela/explore.shtml" TargetMode="External"/><Relationship Id="rId6" Type="http://schemas.openxmlformats.org/officeDocument/2006/relationships/hyperlink" Target="http://genome-www.stanford.edu/Human-CellCycle/Hela/explore.shtml" TargetMode="External"/><Relationship Id="rId7" Type="http://schemas.openxmlformats.org/officeDocument/2006/relationships/image" Target="../media/image1.png"/><Relationship Id="rId8" Type="http://schemas.openxmlformats.org/officeDocument/2006/relationships/image" Target="../media/image2.png"/><Relationship Id="rId9" Type="http://schemas.openxmlformats.org/officeDocument/2006/relationships/image" Target="../media/image3.png"/><Relationship Id="rId10" Type="http://schemas.openxmlformats.org/officeDocument/2006/relationships/image" Target="../media/image4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62120" y="6705720"/>
            <a:ext cx="5562360" cy="19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Supplementary Figure 3. </a:t>
            </a:r>
            <a:r>
              <a:rPr b="1" lang="en-IE" sz="1000" spc="-1" strike="noStrike">
                <a:solidFill>
                  <a:srgbClr val="000000"/>
                </a:solidFill>
                <a:latin typeface="Times New Roman"/>
              </a:rPr>
              <a:t>Periodicity of DRAK2 expression with cell cycle progression in Hela Cells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. Expression of cell cycle phase markers (</a:t>
            </a:r>
            <a:r>
              <a:rPr b="0" i="1" lang="en-IE" sz="1000" spc="-1" strike="noStrike">
                <a:solidFill>
                  <a:srgbClr val="000000"/>
                </a:solidFill>
                <a:latin typeface="Times New Roman"/>
              </a:rPr>
              <a:t>top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), DRAK2 (</a:t>
            </a:r>
            <a:r>
              <a:rPr b="0" i="1" lang="en-IE" sz="1000" spc="-1" strike="noStrike">
                <a:solidFill>
                  <a:srgbClr val="000000"/>
                </a:solidFill>
                <a:latin typeface="Times New Roman"/>
              </a:rPr>
              <a:t>middle, single bar and line graph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) and a panel of 50 other genes (</a:t>
            </a:r>
            <a:r>
              <a:rPr b="0" i="1" lang="en-IE" sz="1000" spc="-1" strike="noStrike">
                <a:solidFill>
                  <a:srgbClr val="000000"/>
                </a:solidFill>
                <a:latin typeface="Times New Roman"/>
              </a:rPr>
              <a:t>bottom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</a:rPr>
              <a:t>) which are co-regulated in their changes in expression with DRAK2 in this expression series. Red indicates increases in gene expression, green indicates decreases in gene expression. The 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expression dataset was interrogated using a tool available at (</a:t>
            </a:r>
            <a:r>
              <a:rPr b="0" lang="en-GB" sz="1000" spc="-1" strike="noStrike" u="sng">
                <a:solidFill>
                  <a:srgbClr val="ccccff"/>
                </a:solidFill>
                <a:uFillTx/>
                <a:latin typeface="Times New Roman"/>
                <a:hlinkClick r:id="rId1"/>
              </a:rPr>
              <a:t>http://genome-www.</a:t>
            </a:r>
            <a:r>
              <a:rPr b="0" lang="en-GB" sz="1000" spc="-1" strike="noStrike" u="sng">
                <a:solidFill>
                  <a:srgbClr val="ccccff"/>
                </a:solidFill>
                <a:uFillTx/>
                <a:latin typeface="Times New Roman"/>
                <a:hlinkClick r:id="rId2"/>
              </a:rPr>
              <a:t>stanford</a:t>
            </a:r>
            <a:r>
              <a:rPr b="0" lang="en-GB" sz="1000" spc="-1" strike="noStrike" u="sng">
                <a:solidFill>
                  <a:srgbClr val="ccccff"/>
                </a:solidFill>
                <a:uFillTx/>
                <a:latin typeface="Times New Roman"/>
                <a:hlinkClick r:id="rId3"/>
              </a:rPr>
              <a:t>.</a:t>
            </a:r>
            <a:r>
              <a:rPr b="0" lang="en-GB" sz="1000" spc="-1" strike="noStrike" u="sng">
                <a:solidFill>
                  <a:srgbClr val="ccccff"/>
                </a:solidFill>
                <a:uFillTx/>
                <a:latin typeface="Times New Roman"/>
                <a:hlinkClick r:id="rId4"/>
              </a:rPr>
              <a:t>edu/Human-CellCycle/Hela/explore</a:t>
            </a:r>
            <a:r>
              <a:rPr b="0" lang="en-GB" sz="1000" spc="-1" strike="noStrike" u="sng">
                <a:solidFill>
                  <a:srgbClr val="ccccff"/>
                </a:solidFill>
                <a:uFillTx/>
                <a:latin typeface="Times New Roman"/>
                <a:hlinkClick r:id="rId5"/>
              </a:rPr>
              <a:t>.</a:t>
            </a:r>
            <a:r>
              <a:rPr b="0" lang="en-GB" sz="1000" spc="-1" strike="noStrike" u="sng">
                <a:solidFill>
                  <a:srgbClr val="ccccff"/>
                </a:solidFill>
                <a:uFillTx/>
                <a:latin typeface="Times New Roman"/>
                <a:hlinkClick r:id="rId6"/>
              </a:rPr>
              <a:t>shtml</a:t>
            </a: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).  This dataset was generated by synchronising cell cycle dynamics using a number of techniques. In addition to the commonly used double thymidine block, a thymidine-nocodazole block and a mitotic shake off approach were employed and combined expression data from the three approaches identified &gt;850 genes which show periodic expression during the cell cycle. DRAK2 transcripts are periodically co-expressed with a panel of 50 genes (see Supplementary table 2 for a complete list) which include classic cell cycle regulation genes (such as Cyclin F, Cyclin A2, and cyclin dependent kinase inhibitor p27, Kip1).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52520" y="457200"/>
            <a:ext cx="6481800" cy="5904000"/>
            <a:chOff x="452520" y="457200"/>
            <a:chExt cx="6481800" cy="5904000"/>
          </a:xfrm>
        </p:grpSpPr>
        <p:pic>
          <p:nvPicPr>
            <p:cNvPr id="43" name="" descr="gene expression color diagram. RED = upregulated, GREEN = downregulated"/>
            <p:cNvPicPr/>
            <p:nvPr/>
          </p:nvPicPr>
          <p:blipFill>
            <a:blip r:embed="rId7"/>
            <a:stretch/>
          </p:blipFill>
          <p:spPr>
            <a:xfrm>
              <a:off x="1028880" y="2328840"/>
              <a:ext cx="5400720" cy="403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8"/>
            <a:stretch/>
          </p:blipFill>
          <p:spPr>
            <a:xfrm>
              <a:off x="596880" y="672840"/>
              <a:ext cx="6337440" cy="250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9"/>
            <a:stretch/>
          </p:blipFill>
          <p:spPr>
            <a:xfrm>
              <a:off x="596880" y="1249200"/>
              <a:ext cx="5977080" cy="7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10"/>
            <a:stretch/>
          </p:blipFill>
          <p:spPr>
            <a:xfrm>
              <a:off x="669960" y="1393560"/>
              <a:ext cx="5904000" cy="93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6429600" y="2473200"/>
              <a:ext cx="504720" cy="45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52520" y="1176120"/>
              <a:ext cx="83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STK17</a:t>
              </a:r>
              <a:r>
                <a:rPr b="1" lang="en-IE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52520" y="457200"/>
              <a:ext cx="1657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IE" sz="800" spc="-1" strike="noStrike">
                  <a:solidFill>
                    <a:srgbClr val="000000"/>
                  </a:solidFill>
                  <a:latin typeface="Arial"/>
                </a:rPr>
                <a:t>Phase Marker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2T19:24:48Z</dcterms:created>
  <dc:creator/>
  <dc:description/>
  <dc:language>en-US</dc:language>
  <cp:lastModifiedBy>John O'Dowd</cp:lastModifiedBy>
  <dcterms:modified xsi:type="dcterms:W3CDTF">2009-05-05T21:36:39Z</dcterms:modified>
  <cp:revision>37</cp:revision>
  <dc:subject/>
  <dc:title>PowerPoint Presentation</dc:title>
</cp:coreProperties>
</file>